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7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43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3/1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E149B3B-95FB-21CB-A107-6D554DF8B65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>
            <a:extLst>
              <a:ext uri="{FF2B5EF4-FFF2-40B4-BE49-F238E27FC236}">
                <a16:creationId xmlns:a16="http://schemas.microsoft.com/office/drawing/2014/main" id="{E30EFAB4-C46D-CB86-4BDB-06D1933918F8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400" dirty="0">
                <a:solidFill>
                  <a:schemeClr val="bg1"/>
                </a:solidFill>
              </a:rPr>
              <a:t>Efficacy and Safety of SOF/LDV in HCV-infected children and adolescents on hemodialysi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6B58E09-62A6-09F2-659F-D2F06770F554}"/>
              </a:ext>
            </a:extLst>
          </p:cNvPr>
          <p:cNvSpPr txBox="1"/>
          <p:nvPr/>
        </p:nvSpPr>
        <p:spPr>
          <a:xfrm>
            <a:off x="180183" y="1189759"/>
            <a:ext cx="11353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600" dirty="0">
                <a:solidFill>
                  <a:schemeClr val="bg1"/>
                </a:solidFill>
              </a:rPr>
              <a:t>To evaluate the safety and efficacy of SOF-based direct-acting antivirals in HCV-infected pediatric CKD patients on hemodialysis</a:t>
            </a:r>
            <a:r>
              <a:rPr lang="en-GB" dirty="0">
                <a:solidFill>
                  <a:schemeClr val="bg1"/>
                </a:solidFill>
              </a:rPr>
              <a:t>.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9434F02-AB8C-CF5C-2822-5997659D213F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Enayet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3B533D0-907C-86B8-1A4B-06BD1A4B05A6}"/>
              </a:ext>
            </a:extLst>
          </p:cNvPr>
          <p:cNvSpPr txBox="1"/>
          <p:nvPr/>
        </p:nvSpPr>
        <p:spPr>
          <a:xfrm>
            <a:off x="173448" y="5719172"/>
            <a:ext cx="7141846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600" dirty="0">
                <a:solidFill>
                  <a:schemeClr val="bg1"/>
                </a:solidFill>
              </a:rPr>
              <a:t>SOF/LDV has been found effective in treating HCV in children and adolescents with CKD on HD, achieving an SVR12 of 86.36% with no </a:t>
            </a:r>
            <a:r>
              <a:rPr lang="en-US" sz="1600">
                <a:solidFill>
                  <a:schemeClr val="bg1"/>
                </a:solidFill>
              </a:rPr>
              <a:t>notable serious adverse </a:t>
            </a:r>
            <a:r>
              <a:rPr lang="en-US" sz="1600" dirty="0">
                <a:solidFill>
                  <a:schemeClr val="bg1"/>
                </a:solidFill>
              </a:rPr>
              <a:t>events reported</a:t>
            </a:r>
            <a:r>
              <a:rPr lang="en-GB" dirty="0">
                <a:solidFill>
                  <a:schemeClr val="bg1"/>
                </a:solidFill>
              </a:rPr>
              <a:t>. </a:t>
            </a:r>
          </a:p>
          <a:p>
            <a:pPr>
              <a:spcAft>
                <a:spcPts val="600"/>
              </a:spcAft>
            </a:pP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BDD162D-A7DF-239F-BBBF-71BCEA46A86A}"/>
              </a:ext>
            </a:extLst>
          </p:cNvPr>
          <p:cNvSpPr/>
          <p:nvPr/>
        </p:nvSpPr>
        <p:spPr>
          <a:xfrm>
            <a:off x="432619" y="2821858"/>
            <a:ext cx="2192594" cy="1376516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r>
              <a:rPr lang="en-GB" b="1" dirty="0">
                <a:solidFill>
                  <a:srgbClr val="0065AA"/>
                </a:solidFill>
              </a:rPr>
              <a:t>DESIGN &amp; OUTCOMES: a prospective study</a:t>
            </a:r>
            <a:endParaRPr lang="ar-EG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0772A3E2-6AE0-4F61-2CA8-50250EF51DBA}"/>
              </a:ext>
            </a:extLst>
          </p:cNvPr>
          <p:cNvSpPr/>
          <p:nvPr/>
        </p:nvSpPr>
        <p:spPr>
          <a:xfrm>
            <a:off x="4286867" y="1918213"/>
            <a:ext cx="3195482" cy="688258"/>
          </a:xfrm>
          <a:prstGeom prst="rect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dirty="0"/>
              <a:t>22 Egyptian children with CKD and on HD </a:t>
            </a:r>
            <a:endParaRPr lang="ar-EG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30448642-8113-4A08-157B-E84B2FB58A6C}"/>
              </a:ext>
            </a:extLst>
          </p:cNvPr>
          <p:cNvSpPr/>
          <p:nvPr/>
        </p:nvSpPr>
        <p:spPr>
          <a:xfrm>
            <a:off x="7905135" y="1918213"/>
            <a:ext cx="2635045" cy="688258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</a:rPr>
              <a:t>Chronic HCV positive</a:t>
            </a:r>
          </a:p>
          <a:p>
            <a:pPr algn="ctr"/>
            <a:r>
              <a:rPr lang="en-US" sz="1400" dirty="0">
                <a:solidFill>
                  <a:schemeClr val="tx1"/>
                </a:solidFill>
              </a:rPr>
              <a:t>Median (IQR) of HCV RNA level was 62,446 (6,875-604,000) IU/L</a:t>
            </a:r>
            <a:endParaRPr lang="ar-EG" sz="1400" dirty="0">
              <a:solidFill>
                <a:schemeClr val="tx1"/>
              </a:solidFill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AD99D76A-3158-E5BB-0122-6D12F82329FF}"/>
              </a:ext>
            </a:extLst>
          </p:cNvPr>
          <p:cNvCxnSpPr>
            <a:stCxn id="4" idx="3"/>
            <a:endCxn id="7" idx="1"/>
          </p:cNvCxnSpPr>
          <p:nvPr/>
        </p:nvCxnSpPr>
        <p:spPr>
          <a:xfrm>
            <a:off x="7482349" y="2262342"/>
            <a:ext cx="422786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F4EC92D2-3A84-4951-BBD5-67701E6FF483}"/>
              </a:ext>
            </a:extLst>
          </p:cNvPr>
          <p:cNvCxnSpPr>
            <a:stCxn id="4" idx="2"/>
          </p:cNvCxnSpPr>
          <p:nvPr/>
        </p:nvCxnSpPr>
        <p:spPr>
          <a:xfrm flipH="1">
            <a:off x="5856711" y="2606471"/>
            <a:ext cx="27897" cy="111995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>
            <a:extLst>
              <a:ext uri="{FF2B5EF4-FFF2-40B4-BE49-F238E27FC236}">
                <a16:creationId xmlns:a16="http://schemas.microsoft.com/office/drawing/2014/main" id="{CE9597A2-A898-2A40-1616-F6609D163672}"/>
              </a:ext>
            </a:extLst>
          </p:cNvPr>
          <p:cNvSpPr/>
          <p:nvPr/>
        </p:nvSpPr>
        <p:spPr>
          <a:xfrm>
            <a:off x="6015742" y="2821858"/>
            <a:ext cx="1958220" cy="567257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12-week course of (SOF/LDV)</a:t>
            </a:r>
            <a:endParaRPr lang="ar-EG" dirty="0">
              <a:solidFill>
                <a:schemeClr val="tx1"/>
              </a:solidFill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8F23865-9425-11B4-750C-84C27630064A}"/>
              </a:ext>
            </a:extLst>
          </p:cNvPr>
          <p:cNvCxnSpPr/>
          <p:nvPr/>
        </p:nvCxnSpPr>
        <p:spPr>
          <a:xfrm flipH="1">
            <a:off x="4109884" y="3696929"/>
            <a:ext cx="173047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ACBF48D0-263A-6EE0-ADA6-19DB646A8486}"/>
              </a:ext>
            </a:extLst>
          </p:cNvPr>
          <p:cNvCxnSpPr/>
          <p:nvPr/>
        </p:nvCxnSpPr>
        <p:spPr>
          <a:xfrm>
            <a:off x="4109884" y="3726426"/>
            <a:ext cx="0" cy="6784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21">
            <a:extLst>
              <a:ext uri="{FF2B5EF4-FFF2-40B4-BE49-F238E27FC236}">
                <a16:creationId xmlns:a16="http://schemas.microsoft.com/office/drawing/2014/main" id="{1F322AF0-E92C-BC05-DA24-B63AC7104901}"/>
              </a:ext>
            </a:extLst>
          </p:cNvPr>
          <p:cNvSpPr/>
          <p:nvPr/>
        </p:nvSpPr>
        <p:spPr>
          <a:xfrm>
            <a:off x="3067670" y="4447497"/>
            <a:ext cx="1809127" cy="521108"/>
          </a:xfrm>
          <a:prstGeom prst="rect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600" dirty="0"/>
              <a:t>1 discontinued due to severe vomiting</a:t>
            </a:r>
            <a:endParaRPr lang="ar-EG" sz="1600" dirty="0"/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063F8638-FF1D-D472-D64D-B02EC9DC2DB4}"/>
              </a:ext>
            </a:extLst>
          </p:cNvPr>
          <p:cNvCxnSpPr/>
          <p:nvPr/>
        </p:nvCxnSpPr>
        <p:spPr>
          <a:xfrm>
            <a:off x="5856711" y="3696929"/>
            <a:ext cx="1823145" cy="294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D177D963-4A3B-932C-F39C-000594BFBB45}"/>
              </a:ext>
            </a:extLst>
          </p:cNvPr>
          <p:cNvCxnSpPr/>
          <p:nvPr/>
        </p:nvCxnSpPr>
        <p:spPr>
          <a:xfrm>
            <a:off x="7679856" y="3726426"/>
            <a:ext cx="0" cy="72107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CDB2089C-72CD-71DF-0104-DFF6BC1E1AB3}"/>
              </a:ext>
            </a:extLst>
          </p:cNvPr>
          <p:cNvSpPr/>
          <p:nvPr/>
        </p:nvSpPr>
        <p:spPr>
          <a:xfrm>
            <a:off x="6705601" y="4457329"/>
            <a:ext cx="2458062" cy="584338"/>
          </a:xfrm>
          <a:prstGeom prst="rect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21 patients continued with minimal adverse reactions </a:t>
            </a:r>
            <a:endParaRPr lang="ar-EG" sz="1600" dirty="0">
              <a:solidFill>
                <a:schemeClr val="tx1"/>
              </a:solidFill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AB6BF30E-1207-0026-4AE5-0224870E50D8}"/>
              </a:ext>
            </a:extLst>
          </p:cNvPr>
          <p:cNvCxnSpPr>
            <a:stCxn id="31" idx="3"/>
          </p:cNvCxnSpPr>
          <p:nvPr/>
        </p:nvCxnSpPr>
        <p:spPr>
          <a:xfrm>
            <a:off x="9163663" y="4749498"/>
            <a:ext cx="737421" cy="931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Rectangle 33">
            <a:extLst>
              <a:ext uri="{FF2B5EF4-FFF2-40B4-BE49-F238E27FC236}">
                <a16:creationId xmlns:a16="http://schemas.microsoft.com/office/drawing/2014/main" id="{CC52AC3A-61B7-013F-5C34-586B8B63FD10}"/>
              </a:ext>
            </a:extLst>
          </p:cNvPr>
          <p:cNvSpPr/>
          <p:nvPr/>
        </p:nvSpPr>
        <p:spPr>
          <a:xfrm>
            <a:off x="9901083" y="4198373"/>
            <a:ext cx="2153264" cy="1007125"/>
          </a:xfrm>
          <a:prstGeom prst="rect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</a:rPr>
              <a:t>19 patients achieved  a sustained virologic response (SVR) at 12 weeks </a:t>
            </a:r>
            <a:endParaRPr lang="ar-EG" sz="1400" dirty="0">
              <a:solidFill>
                <a:schemeClr val="tx1"/>
              </a:solidFill>
            </a:endParaRPr>
          </a:p>
        </p:txBody>
      </p:sp>
      <p:pic>
        <p:nvPicPr>
          <p:cNvPr id="1026" name="Picture 2" descr="Figure 2 from Hemodialysis machine technology: a global overview ...">
            <a:extLst>
              <a:ext uri="{FF2B5EF4-FFF2-40B4-BE49-F238E27FC236}">
                <a16:creationId xmlns:a16="http://schemas.microsoft.com/office/drawing/2014/main" id="{4FD05259-05D6-0528-0A81-7E4D0D72895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3482" y="1625531"/>
            <a:ext cx="733384" cy="14763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9CE18EA-DE11-F130-C78F-6FBA926ED23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8610" t="12615" r="4894" b="22875"/>
          <a:stretch>
            <a:fillRect/>
          </a:stretch>
        </p:blipFill>
        <p:spPr>
          <a:xfrm>
            <a:off x="7454452" y="3069172"/>
            <a:ext cx="1144497" cy="567257"/>
          </a:xfrm>
          <a:prstGeom prst="rect">
            <a:avLst/>
          </a:prstGeom>
        </p:spPr>
      </p:pic>
      <p:pic>
        <p:nvPicPr>
          <p:cNvPr id="1032" name="Picture 8" descr="Premium Photo | Pcr hcv rna test for the diagnosis of hepatitis c virus ...">
            <a:extLst>
              <a:ext uri="{FF2B5EF4-FFF2-40B4-BE49-F238E27FC236}">
                <a16:creationId xmlns:a16="http://schemas.microsoft.com/office/drawing/2014/main" id="{AAC296A4-6902-2EE6-EFEF-BD28ACB9B6C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77831" y="1749051"/>
            <a:ext cx="1370961" cy="10158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AutoShape 12" descr="Be Patient Sign">
            <a:extLst>
              <a:ext uri="{FF2B5EF4-FFF2-40B4-BE49-F238E27FC236}">
                <a16:creationId xmlns:a16="http://schemas.microsoft.com/office/drawing/2014/main" id="{B0557A0B-EBA7-7F83-DD79-39A27A29EA28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ar-EG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7638972B-120E-6352-2ED0-6E0B608CF476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5203" t="35317" r="81870" b="19697"/>
          <a:stretch>
            <a:fillRect/>
          </a:stretch>
        </p:blipFill>
        <p:spPr>
          <a:xfrm>
            <a:off x="3084437" y="1730300"/>
            <a:ext cx="566223" cy="126228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1ECDC7EA-8583-D484-CBCC-9B432026CE37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9261" r="19110" b="19426"/>
          <a:stretch>
            <a:fillRect/>
          </a:stretch>
        </p:blipFill>
        <p:spPr>
          <a:xfrm>
            <a:off x="10593837" y="3069587"/>
            <a:ext cx="809434" cy="1128786"/>
          </a:xfrm>
          <a:prstGeom prst="rect">
            <a:avLst/>
          </a:prstGeom>
        </p:spPr>
      </p:pic>
      <p:sp>
        <p:nvSpPr>
          <p:cNvPr id="11" name="Multiplication Sign 10">
            <a:extLst>
              <a:ext uri="{FF2B5EF4-FFF2-40B4-BE49-F238E27FC236}">
                <a16:creationId xmlns:a16="http://schemas.microsoft.com/office/drawing/2014/main" id="{DEFACB2A-A196-8AE8-A63F-67532545C90D}"/>
              </a:ext>
            </a:extLst>
          </p:cNvPr>
          <p:cNvSpPr/>
          <p:nvPr/>
        </p:nvSpPr>
        <p:spPr>
          <a:xfrm>
            <a:off x="10655814" y="3249561"/>
            <a:ext cx="685480" cy="1092887"/>
          </a:xfrm>
          <a:prstGeom prst="mathMultiply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2160339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42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5-12-03T17:04:16Z</dcterms:modified>
</cp:coreProperties>
</file>